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7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72000" y="889844"/>
            <a:ext cx="9072000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chanical </a:t>
            </a:r>
            <a:r>
              <a:rPr lang="en-GB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ss induces elastic fibre disruption and </a:t>
            </a:r>
            <a:endParaRPr lang="en-GB" altLang="ja-JP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tilage </a:t>
            </a:r>
            <a:r>
              <a:rPr lang="en-GB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rix increase in ligamentum flavum</a:t>
            </a:r>
            <a:endParaRPr lang="ja-JP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zunori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yashi, M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kinobu Suzuki*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yed Abdullah,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D.</a:t>
            </a:r>
            <a:r>
              <a:rPr lang="en-GB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endParaRPr lang="en-GB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detomi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ai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ntaro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amada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satoshi Hoshino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romitsu Toyoda, M.D.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inji Takahashi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oji Tamai,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D.</a:t>
            </a:r>
            <a:r>
              <a:rPr lang="en-GB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endParaRPr lang="en-GB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ichiro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hyama, M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gar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vid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D., Ph.D.</a:t>
            </a:r>
            <a:r>
              <a:rPr lang="en-GB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hammad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hrab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D.</a:t>
            </a:r>
            <a:r>
              <a:rPr lang="en-GB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</a:p>
          <a:p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uf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hammad </a:t>
            </a:r>
            <a:r>
              <a:rPr lang="en-GB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ib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roaki Nakamura, M.D., Ph.D.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s: 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: Department of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paedic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ery, Osaka City University Graduate School of Medicine, Osaka, Japan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83821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E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profile of the LF in L2-3 and L4-5 LF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(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3a1</a:t>
            </a:r>
            <a:endParaRPr kumimoji="1" lang="ja-JP" altLang="en-US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1344168"/>
            <a:ext cx="6114286" cy="4169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713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esktop\SFig.1A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2075" y="1484784"/>
            <a:ext cx="5184576" cy="4940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A</a:t>
            </a:r>
          </a:p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surement of L3-4 disc height: (A)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surement methods;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anterior ; 2 middle; 3 posterior; Disc height = (1+2+3)/3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382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B</a:t>
            </a:r>
          </a:p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surement of L3-4 disc height: (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The measurement data in group S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808" y="1487424"/>
            <a:ext cx="6120384" cy="3883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8405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C</a:t>
            </a:r>
          </a:p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surement of L3-4 disc height: (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The measurement data in group F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808" y="1487424"/>
            <a:ext cx="6120384" cy="3883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0846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D</a:t>
            </a:r>
          </a:p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surement of L3-4 disc height: (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The measurement data in group F+C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6605" y="1487424"/>
            <a:ext cx="6110789" cy="3883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29690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A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profile of the LF in L2-3 and L4-5 LF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(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1" lang="en-US" altLang="ja-JP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2a1</a:t>
            </a:r>
            <a:endParaRPr kumimoji="1" lang="ja-JP" altLang="en-US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1344168"/>
            <a:ext cx="6114287" cy="41696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35147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B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profile of the LF in L2-3 and L4-5 LF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(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1" lang="en-US" altLang="ja-JP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astin</a:t>
            </a:r>
            <a:endParaRPr kumimoji="1" lang="ja-JP" altLang="en-US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1344168"/>
            <a:ext cx="6114287" cy="4169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78193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C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profile of the LF in L2-3 and L4-5 LF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(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1a1</a:t>
            </a:r>
            <a:endParaRPr kumimoji="1" lang="ja-JP" altLang="en-US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1344168"/>
            <a:ext cx="6114287" cy="4169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16423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51520" y="188640"/>
            <a:ext cx="8748464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D</a:t>
            </a:r>
          </a:p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profile of the LF in L2-3 and L4-5 LF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(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1a2</a:t>
            </a:r>
            <a:endParaRPr kumimoji="1" lang="ja-JP" altLang="en-US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1344168"/>
            <a:ext cx="6114286" cy="4169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0724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207</Words>
  <Application>Microsoft Office PowerPoint</Application>
  <PresentationFormat>画面に合わせる (4:3)</PresentationFormat>
  <Paragraphs>29</Paragraphs>
  <Slides>10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1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林和憲</dc:creator>
  <cp:lastModifiedBy>user</cp:lastModifiedBy>
  <cp:revision>7</cp:revision>
  <dcterms:created xsi:type="dcterms:W3CDTF">2017-09-04T04:49:48Z</dcterms:created>
  <dcterms:modified xsi:type="dcterms:W3CDTF">2017-09-10T07:34:05Z</dcterms:modified>
</cp:coreProperties>
</file>